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/>
    <p:restoredTop sz="94652"/>
  </p:normalViewPr>
  <p:slideViewPr>
    <p:cSldViewPr>
      <p:cViewPr varScale="1">
        <p:scale>
          <a:sx n="133" d="100"/>
          <a:sy n="133" d="100"/>
        </p:scale>
        <p:origin x="184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FE861C-486B-4E18-A0E9-A790238A915C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811066-0135-4CAA-8AD4-89A97190AC0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2BAB4-8B8D-41DD-85C7-81A0CA962007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EAD0F5-E869-4348-A5D7-0DD87A3B21D1}"/>
              </a:ext>
            </a:extLst>
          </p:cNvPr>
          <p:cNvSpPr txBox="1"/>
          <p:nvPr/>
        </p:nvSpPr>
        <p:spPr>
          <a:xfrm>
            <a:off x="76200" y="5943600"/>
            <a:ext cx="8991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7 Fig. Median-joining network for PpSP44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plotype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le size and circle color indicates frequency and geographical location of haplotypes, respectively. Haplotype numbers are written next to the corresponding circle H_XX. Red numbers between haplotypes indicate number of mutations between haplotype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2ACA86F-FEB7-0F4B-9471-E27E5C626A9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250" y="65923"/>
            <a:ext cx="6667500" cy="588088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Macintosh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2-08-24T00:53:15Z</dcterms:created>
  <dcterms:modified xsi:type="dcterms:W3CDTF">2020-06-22T01:59:00Z</dcterms:modified>
</cp:coreProperties>
</file>